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0" d="100"/>
          <a:sy n="90" d="100"/>
        </p:scale>
        <p:origin x="-88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719F2-84B7-4479-AD70-54B280CF172D}" type="datetimeFigureOut">
              <a:rPr kumimoji="1" lang="ja-JP" altLang="en-US" smtClean="0"/>
              <a:t>2017/9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D3F20B-B456-4119-8E0C-E0A4CAAD4C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620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719F2-84B7-4479-AD70-54B280CF172D}" type="datetimeFigureOut">
              <a:rPr kumimoji="1" lang="ja-JP" altLang="en-US" smtClean="0"/>
              <a:t>2017/9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D3F20B-B456-4119-8E0C-E0A4CAAD4C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72919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719F2-84B7-4479-AD70-54B280CF172D}" type="datetimeFigureOut">
              <a:rPr kumimoji="1" lang="ja-JP" altLang="en-US" smtClean="0"/>
              <a:t>2017/9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D3F20B-B456-4119-8E0C-E0A4CAAD4C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45106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719F2-84B7-4479-AD70-54B280CF172D}" type="datetimeFigureOut">
              <a:rPr kumimoji="1" lang="ja-JP" altLang="en-US" smtClean="0"/>
              <a:t>2017/9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D3F20B-B456-4119-8E0C-E0A4CAAD4C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12426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719F2-84B7-4479-AD70-54B280CF172D}" type="datetimeFigureOut">
              <a:rPr kumimoji="1" lang="ja-JP" altLang="en-US" smtClean="0"/>
              <a:t>2017/9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D3F20B-B456-4119-8E0C-E0A4CAAD4C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5355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719F2-84B7-4479-AD70-54B280CF172D}" type="datetimeFigureOut">
              <a:rPr kumimoji="1" lang="ja-JP" altLang="en-US" smtClean="0"/>
              <a:t>2017/9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D3F20B-B456-4119-8E0C-E0A4CAAD4C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67092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719F2-84B7-4479-AD70-54B280CF172D}" type="datetimeFigureOut">
              <a:rPr kumimoji="1" lang="ja-JP" altLang="en-US" smtClean="0"/>
              <a:t>2017/9/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D3F20B-B456-4119-8E0C-E0A4CAAD4C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7118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719F2-84B7-4479-AD70-54B280CF172D}" type="datetimeFigureOut">
              <a:rPr kumimoji="1" lang="ja-JP" altLang="en-US" smtClean="0"/>
              <a:t>2017/9/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D3F20B-B456-4119-8E0C-E0A4CAAD4C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53257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719F2-84B7-4479-AD70-54B280CF172D}" type="datetimeFigureOut">
              <a:rPr kumimoji="1" lang="ja-JP" altLang="en-US" smtClean="0"/>
              <a:t>2017/9/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D3F20B-B456-4119-8E0C-E0A4CAAD4C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887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719F2-84B7-4479-AD70-54B280CF172D}" type="datetimeFigureOut">
              <a:rPr kumimoji="1" lang="ja-JP" altLang="en-US" smtClean="0"/>
              <a:t>2017/9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D3F20B-B456-4119-8E0C-E0A4CAAD4C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44228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719F2-84B7-4479-AD70-54B280CF172D}" type="datetimeFigureOut">
              <a:rPr kumimoji="1" lang="ja-JP" altLang="en-US" smtClean="0"/>
              <a:t>2017/9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D3F20B-B456-4119-8E0C-E0A4CAAD4C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99051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3719F2-84B7-4479-AD70-54B280CF172D}" type="datetimeFigureOut">
              <a:rPr kumimoji="1" lang="ja-JP" altLang="en-US" smtClean="0"/>
              <a:t>2017/9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D3F20B-B456-4119-8E0C-E0A4CAAD4C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38575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tkawa\Desktop\K37616276.chr19.54676763.varld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679"/>
          <a:stretch/>
        </p:blipFill>
        <p:spPr bwMode="auto">
          <a:xfrm>
            <a:off x="1475655" y="12725"/>
            <a:ext cx="6188075" cy="57752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テキスト ボックス 4"/>
          <p:cNvSpPr txBox="1"/>
          <p:nvPr/>
        </p:nvSpPr>
        <p:spPr>
          <a:xfrm>
            <a:off x="1187624" y="5229200"/>
            <a:ext cx="691276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 Fig.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ional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ots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ound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rs641738 in the study of all NAFLD patients compared to controls</a:t>
            </a:r>
          </a:p>
          <a:p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values,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organization, and linkage disequilibrium (LD) plots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JPT and CEU populations of the 1000 genome project phase3 were plotted. In the upper panel, red and blue circles denote p-values of the genotyped SNPs and the imputed SNPs respectively. Imputation was performed by referencing the 1000 genome phase3 JPT dataset, and subsequently the SNPs with </a:t>
            </a:r>
            <a:r>
              <a:rPr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sq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gt;0.5 as quality score were plotted. The brightness of the red color in the LD plots in the lower panel corresponds to the strength of LD. 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48999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110</Words>
  <Application>Microsoft Office PowerPoint</Application>
  <PresentationFormat>画面に合わせる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kawa</dc:creator>
  <cp:lastModifiedBy>tkawa</cp:lastModifiedBy>
  <cp:revision>6</cp:revision>
  <dcterms:created xsi:type="dcterms:W3CDTF">2017-09-06T10:47:46Z</dcterms:created>
  <dcterms:modified xsi:type="dcterms:W3CDTF">2017-09-08T04:29:09Z</dcterms:modified>
</cp:coreProperties>
</file>